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49C45-E651-4B8F-8AE5-FD3E154D4C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C3B3E4-23AB-43E3-A27B-71F44568C8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E6B55-EB4F-405A-9C2E-9C48B31CF6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7ACA8-56D4-4488-8B6B-117C22A6D9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D940C-D949-442F-87F2-E6D16C2082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573E1-6A65-42CF-BE03-5CF5A84E1A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8BEA6-0191-47DB-9080-DD69B4169C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B72D3-961A-4685-BAEB-61410721B7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C3B72-871C-4A0F-A3C6-B3B8451515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266AD-47C9-467C-8035-C43DA1E1AF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1ADD2-8B65-48F8-B742-DD05C6CAF2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E670C-033C-46C8-A357-4C43A0FDA4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81E316-7B23-4CC6-9204-DBFC3BE4B502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14400" y="380880"/>
            <a:ext cx="586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4: Detection of microRNA gene targ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52280" y="5013360"/>
            <a:ext cx="77724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croRNA chromosomal location according to the miRBase database from Sanger Institut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croRNA expression levels according to the TaqMan miR assay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76320" y="898560"/>
            <a:ext cx="8686800" cy="4065120"/>
            <a:chOff x="76320" y="898560"/>
            <a:chExt cx="8686800" cy="4065120"/>
          </a:xfrm>
        </p:grpSpPr>
        <p:sp>
          <p:nvSpPr>
            <p:cNvPr id="44" name=""/>
            <p:cNvSpPr/>
            <p:nvPr/>
          </p:nvSpPr>
          <p:spPr>
            <a:xfrm>
              <a:off x="76320" y="898560"/>
              <a:ext cx="11430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icroRNA gen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352680" y="898560"/>
              <a:ext cx="11430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utative Target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303800" y="9748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Descriptio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28600" y="936720"/>
              <a:ext cx="8534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62000" y="13381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52680" y="13302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PPAR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388400" y="1336680"/>
              <a:ext cx="4075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100" spc="-1" strike="noStrike">
                  <a:solidFill>
                    <a:srgbClr val="000000"/>
                  </a:solidFill>
                  <a:latin typeface="Arial"/>
                </a:rPr>
                <a:t>Peroxisome proliferator-activated receptor alpha (PPAR-alpha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581280" y="1533600"/>
              <a:ext cx="85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MP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384800" y="1535040"/>
              <a:ext cx="399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one morphogenetic protein-7 or osteogenic protein 1 (OP-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90440" y="16984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10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581280" y="1717560"/>
              <a:ext cx="91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COX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393800" y="1711440"/>
              <a:ext cx="1901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cyl-coenzyme A oxidase 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0440" y="23652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9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581280" y="2343240"/>
              <a:ext cx="609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E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389840" y="2340000"/>
              <a:ext cx="1563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eptin (Obesity factor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143000" y="898560"/>
              <a:ext cx="12193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Chromosomal location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286000" y="898560"/>
              <a:ext cx="11430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Expression in OA group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28600" y="1330200"/>
              <a:ext cx="8534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8600" y="4937040"/>
              <a:ext cx="8534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282760" y="13302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282760" y="17114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282760" y="23605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39760" y="13381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7p13.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139760" y="17114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q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139760" y="23572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q32.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90440" y="19144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3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581280" y="1919160"/>
              <a:ext cx="91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ET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395960" y="1914480"/>
              <a:ext cx="1409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esistin (adipokine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282760" y="19112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139760" y="19144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4q32.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42920" y="21286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581280" y="2146320"/>
              <a:ext cx="91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ITGA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398120" y="2143080"/>
              <a:ext cx="1576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Integrin alpha 5 beta 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282760" y="21384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139760" y="214956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7q22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90440" y="25686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37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584520" y="2557440"/>
              <a:ext cx="695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SP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393080" y="2556000"/>
              <a:ext cx="1482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spase 6 precurso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282760" y="25560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139760" y="25621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9q13.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90440" y="27716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571920" y="277164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SP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393080" y="2765520"/>
              <a:ext cx="1559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spase 10 precurso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282760" y="27702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139760" y="27716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1p15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90440" y="29941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37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581280" y="298620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RT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393800" y="2994120"/>
              <a:ext cx="1753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rtilage homeoprotein 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282760" y="29908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139760" y="29941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4q32.31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90440" y="31910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1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587760" y="320040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DAMTS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388400" y="3184560"/>
              <a:ext cx="4231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A disintegrin and metalloproteinase with thrombospondin motifs 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282760" y="319896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139760" y="31910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6q22.1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90440" y="34066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48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587760" y="341640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CA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393080" y="3413160"/>
              <a:ext cx="1559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ggrecan core protei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282760" y="34146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139760" y="34066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1p15.5 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90440" y="36226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2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587760" y="363060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DF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388760" y="3629160"/>
              <a:ext cx="204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rowth/Differentiation factor 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282760" y="36226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139760" y="362916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Xq12  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90440" y="384480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3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587760" y="384480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RTA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391280" y="3844800"/>
              <a:ext cx="2549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artilage associated protein precurso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282760" y="38498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139760" y="385128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9q22.32  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90440" y="40543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30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587760" y="405936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DF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388760" y="4054320"/>
              <a:ext cx="212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rowth/Differentiation factor 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282760" y="40543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139760" y="40543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8q24.22  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52280" y="42703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587760" y="427356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TP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393800" y="4264200"/>
              <a:ext cx="167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Tropomyosin beta chai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282760" y="42721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139760" y="42703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13q14.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90440" y="44798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26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587760" y="448776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SP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393800" y="4479840"/>
              <a:ext cx="1287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sporin precursor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282760" y="44798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ow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139760" y="448632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3p22.2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90440" y="46958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R-50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587760" y="4702320"/>
              <a:ext cx="8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OX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391640" y="4695840"/>
              <a:ext cx="1794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Transcription factor SOX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282760" y="46958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Hig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139760" y="4695840"/>
              <a:ext cx="114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Xq27.3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imitrios</cp:lastModifiedBy>
  <dcterms:modified xsi:type="dcterms:W3CDTF">2008-10-31T02:30:27Z</dcterms:modified>
  <cp:revision>10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